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2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3" autoAdjust="0"/>
    <p:restoredTop sz="94660"/>
  </p:normalViewPr>
  <p:slideViewPr>
    <p:cSldViewPr snapToGrid="0">
      <p:cViewPr varScale="1">
        <p:scale>
          <a:sx n="161" d="100"/>
          <a:sy n="161" d="100"/>
        </p:scale>
        <p:origin x="180" y="2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3502CC-947C-4ACA-8762-C90683E84E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5CD6E14-3C7E-427D-A373-9FDE17819C4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8F0324-BE39-47C8-A8A0-336FA34594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0B840-BC35-4866-8416-22C46DD9EC3C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54C071-ACAD-4320-B16B-9934676CEF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142DE30-A027-46F2-A2E3-35E7951EFD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1152B-0824-46A5-9986-FB1AA91C4D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03991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D4098A-EC5F-444B-96BE-2F5FD1BD2C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F2A9497-738B-4F56-811A-9A89291160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B4B569-A305-4539-89A2-7DE710F3BA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0B840-BC35-4866-8416-22C46DD9EC3C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ACE54E-C9FA-48F0-8572-24BFB5B2CF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9FC0DD-484D-4BA6-BB1C-B58E3F16AA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1152B-0824-46A5-9986-FB1AA91C4D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07026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371D3BA-986A-4B36-9567-9538E5EE451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2BF0BAD-6794-4D14-B3B7-5D241693F7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06816E-C3BC-4016-89BB-850CEE415A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0B840-BC35-4866-8416-22C46DD9EC3C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ED7D48-067F-478B-8D3A-EC8A5A58C0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4C4C74-3057-4B12-B9FB-590DC48FAB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1152B-0824-46A5-9986-FB1AA91C4D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84201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E4DD7A-1DF6-4AEF-9ACC-2573561A36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3BDDE1D-9209-45F4-A8DB-4DAD52B7BFD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58A1923-963E-426F-9B82-F24CD37699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0B840-BC35-4866-8416-22C46DD9EC3C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8770F2-B6BE-400D-AD9A-4BE14D246B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D5B871-58C4-4972-A04F-FA0C0145A4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1152B-0824-46A5-9986-FB1AA91C4D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88111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86CA4E-CE15-4F90-958B-5D4AD3AB71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7DD990-C55A-4755-B2BE-645611EB63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615B7B-4846-4135-9193-A80422457A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0B840-BC35-4866-8416-22C46DD9EC3C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564E0C-5F98-4CAE-B09E-64772F970C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2A4303-8D57-4DDC-86EB-3E1E4592CB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1152B-0824-46A5-9986-FB1AA91C4D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51502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FA07B0-4B72-428C-91EB-990EE1FC69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F2A1F1-AA2F-4FE7-A6F1-40586F778BB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322F7F2-092E-43F1-9C56-D5CEDDADE1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C78DD5B-6C73-4074-9D05-189508B80E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0B840-BC35-4866-8416-22C46DD9EC3C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AE21C5-D3BD-417D-949C-2D88B25702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F6139B-82B7-46AC-AFAD-6057EFADAB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1152B-0824-46A5-9986-FB1AA91C4D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69743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D3DF37-31FE-4F1B-9894-39F7310D6C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85D9B8F-DE9B-4594-A382-A455B0AF25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D4CF1A5-DAF3-4441-B286-3BC64BC1753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76B3B57-BF80-4200-9D48-EC6D572288B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F6A2E9D-9FE5-4CE5-9F97-C512DEC6D30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146CF4B-143B-4A91-AFD2-8CF234A387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0B840-BC35-4866-8416-22C46DD9EC3C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B33C551-242C-42AC-A179-777D56CAFD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5CE4778-6A74-4F02-BC98-DBE2CE384D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1152B-0824-46A5-9986-FB1AA91C4D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28533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A30861-1C33-44D9-A6D0-DCBAEF6E1B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99886B4-5B77-4C1D-B607-CE43061954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0B840-BC35-4866-8416-22C46DD9EC3C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FA68E8E-1419-4317-8D6A-04832AE510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BCC9878-A1AF-485A-B41B-63DA7C07B6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1152B-0824-46A5-9986-FB1AA91C4D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09874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E7FBA09-925C-472A-A11E-905D683B9C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0B840-BC35-4866-8416-22C46DD9EC3C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EB4A8CD-22E4-4A2C-8D8B-0AA78826FB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C40AF2A-790E-4CF2-8841-26BDFA55FA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1152B-0824-46A5-9986-FB1AA91C4D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73727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D3110E-1E0A-401F-A387-29E49718B1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C624F62-BEDE-45AC-9A80-F4722BC2579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E720F02-57CE-48DF-9FA9-D9397E0733C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18D07A-1DE3-4072-9699-CDAF82B154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0B840-BC35-4866-8416-22C46DD9EC3C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1A2700-1AC4-4ED5-96F2-F0491790DE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7A289CA-9698-4F11-9512-9627B5069C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1152B-0824-46A5-9986-FB1AA91C4D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76235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B9FFD3-DBF2-4078-AF77-A594DB2981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C1538EB-AC46-43AF-BA46-5D7B1D076A1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066D1E2-5C1D-490C-85A8-D95EB45A5F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9347A14-BFDC-4DAE-A1E0-CC7AB4646F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80B840-BC35-4866-8416-22C46DD9EC3C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15B60C-4F9F-4859-A950-5ADF0BBBEB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2EEE805-6D52-40B9-8804-4627A2AD56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1152B-0824-46A5-9986-FB1AA91C4D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93532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8001FF5-426E-46BD-8BA6-E02D37DD4A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3C77959-A726-462C-815D-EB042BB351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6F473F-43EC-4420-8B0F-452EF8D0FEC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80B840-BC35-4866-8416-22C46DD9EC3C}" type="datetimeFigureOut">
              <a:rPr lang="en-GB" smtClean="0"/>
              <a:t>12/01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1C7BEE-B590-4F41-8430-AD5CB96EADE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8891C2-873F-43F7-B5B6-AEEA8AE3C4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51152B-0824-46A5-9986-FB1AA91C4DF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01642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5" Type="http://schemas.microsoft.com/office/2007/relationships/hdphoto" Target="../media/hdphoto4.wdp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picture containing photo, water, plane, airplane&#10;&#10;Description automatically generated">
            <a:extLst>
              <a:ext uri="{FF2B5EF4-FFF2-40B4-BE49-F238E27FC236}">
                <a16:creationId xmlns:a16="http://schemas.microsoft.com/office/drawing/2014/main" id="{730FAA6E-C9D7-4F08-A25A-7E9D23AACE3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825" t="14752" r="22601" b="37534"/>
          <a:stretch/>
        </p:blipFill>
        <p:spPr>
          <a:xfrm>
            <a:off x="1938117" y="1642920"/>
            <a:ext cx="5100050" cy="3012436"/>
          </a:xfrm>
          <a:prstGeom prst="rect">
            <a:avLst/>
          </a:prstGeom>
        </p:spPr>
      </p:pic>
      <p:pic>
        <p:nvPicPr>
          <p:cNvPr id="11" name="Picture 10" descr="A picture containing water, small, flying, person&#10;&#10;Description automatically generated">
            <a:extLst>
              <a:ext uri="{FF2B5EF4-FFF2-40B4-BE49-F238E27FC236}">
                <a16:creationId xmlns:a16="http://schemas.microsoft.com/office/drawing/2014/main" id="{2F11B55D-336B-422D-A755-B7A4BB19B5A5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643" t="26316" r="42042" b="30788"/>
          <a:stretch/>
        </p:blipFill>
        <p:spPr>
          <a:xfrm>
            <a:off x="7390211" y="1630512"/>
            <a:ext cx="3298034" cy="3004032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AA202FAA-3018-4FC1-B443-7CFE7C2036A0}"/>
              </a:ext>
            </a:extLst>
          </p:cNvPr>
          <p:cNvSpPr txBox="1"/>
          <p:nvPr/>
        </p:nvSpPr>
        <p:spPr>
          <a:xfrm>
            <a:off x="3120933" y="873560"/>
            <a:ext cx="1399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FtsZ</a:t>
            </a:r>
            <a:r>
              <a:rPr lang="en-GB" dirty="0"/>
              <a:t> 3.5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1328B2A-DC40-4F4B-9B3A-790D43DFE61A}"/>
              </a:ext>
            </a:extLst>
          </p:cNvPr>
          <p:cNvSpPr txBox="1"/>
          <p:nvPr/>
        </p:nvSpPr>
        <p:spPr>
          <a:xfrm>
            <a:off x="4872009" y="873560"/>
            <a:ext cx="1987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FtsZ</a:t>
            </a:r>
            <a:r>
              <a:rPr lang="en-GB" dirty="0"/>
              <a:t> 3.5 : </a:t>
            </a:r>
            <a:r>
              <a:rPr lang="en-GB" dirty="0" err="1"/>
              <a:t>SepH</a:t>
            </a:r>
            <a:r>
              <a:rPr lang="en-GB" dirty="0"/>
              <a:t> 0.6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2248F75F-0E54-4FC6-AF85-9459C710186E}"/>
              </a:ext>
            </a:extLst>
          </p:cNvPr>
          <p:cNvCxnSpPr/>
          <p:nvPr/>
        </p:nvCxnSpPr>
        <p:spPr>
          <a:xfrm>
            <a:off x="2517429" y="1242892"/>
            <a:ext cx="218541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662068B3-1596-4A77-9B72-371F05E82ECE}"/>
              </a:ext>
            </a:extLst>
          </p:cNvPr>
          <p:cNvCxnSpPr/>
          <p:nvPr/>
        </p:nvCxnSpPr>
        <p:spPr>
          <a:xfrm>
            <a:off x="4772949" y="1242892"/>
            <a:ext cx="218541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5CAF7130-3C28-4F65-9355-630805DFF7AD}"/>
              </a:ext>
            </a:extLst>
          </p:cNvPr>
          <p:cNvCxnSpPr>
            <a:cxnSpLocks/>
          </p:cNvCxnSpPr>
          <p:nvPr/>
        </p:nvCxnSpPr>
        <p:spPr>
          <a:xfrm>
            <a:off x="2517429" y="1605604"/>
            <a:ext cx="106735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FA7F188E-F240-4759-ADFA-649597245402}"/>
              </a:ext>
            </a:extLst>
          </p:cNvPr>
          <p:cNvCxnSpPr>
            <a:cxnSpLocks/>
          </p:cNvCxnSpPr>
          <p:nvPr/>
        </p:nvCxnSpPr>
        <p:spPr>
          <a:xfrm>
            <a:off x="3683086" y="1605604"/>
            <a:ext cx="106735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8BC709B4-A642-4C4C-99E5-EA18602BD93F}"/>
              </a:ext>
            </a:extLst>
          </p:cNvPr>
          <p:cNvCxnSpPr>
            <a:cxnSpLocks/>
          </p:cNvCxnSpPr>
          <p:nvPr/>
        </p:nvCxnSpPr>
        <p:spPr>
          <a:xfrm>
            <a:off x="4842520" y="1605604"/>
            <a:ext cx="106735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8E30DECD-3633-4410-8E80-037916F99FB7}"/>
              </a:ext>
            </a:extLst>
          </p:cNvPr>
          <p:cNvCxnSpPr>
            <a:cxnSpLocks/>
          </p:cNvCxnSpPr>
          <p:nvPr/>
        </p:nvCxnSpPr>
        <p:spPr>
          <a:xfrm>
            <a:off x="5970813" y="1605604"/>
            <a:ext cx="106735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9A8238F1-3877-4539-BF46-F511DE552229}"/>
              </a:ext>
            </a:extLst>
          </p:cNvPr>
          <p:cNvSpPr txBox="1"/>
          <p:nvPr/>
        </p:nvSpPr>
        <p:spPr>
          <a:xfrm>
            <a:off x="2697261" y="1261180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- GTP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D78E8C5-CFD7-42B4-AAE2-8202472E22BF}"/>
              </a:ext>
            </a:extLst>
          </p:cNvPr>
          <p:cNvSpPr txBox="1"/>
          <p:nvPr/>
        </p:nvSpPr>
        <p:spPr>
          <a:xfrm>
            <a:off x="4984348" y="1269538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- GTP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B7DFBB7-6B9C-46D5-A3F7-ACB9F62A2F2C}"/>
              </a:ext>
            </a:extLst>
          </p:cNvPr>
          <p:cNvSpPr txBox="1"/>
          <p:nvPr/>
        </p:nvSpPr>
        <p:spPr>
          <a:xfrm>
            <a:off x="3847881" y="1248727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+ GTP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A049840-CCB0-4F7C-9A1C-67F2645A7BAA}"/>
              </a:ext>
            </a:extLst>
          </p:cNvPr>
          <p:cNvSpPr txBox="1"/>
          <p:nvPr/>
        </p:nvSpPr>
        <p:spPr>
          <a:xfrm>
            <a:off x="6122014" y="1244678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+ GTP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5D77006E-B2A9-4CB4-94C6-D467985767C8}"/>
              </a:ext>
            </a:extLst>
          </p:cNvPr>
          <p:cNvSpPr txBox="1"/>
          <p:nvPr/>
        </p:nvSpPr>
        <p:spPr>
          <a:xfrm>
            <a:off x="8358276" y="795492"/>
            <a:ext cx="1987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FtsZ</a:t>
            </a:r>
            <a:r>
              <a:rPr lang="en-GB" dirty="0"/>
              <a:t> 3.5 : </a:t>
            </a:r>
            <a:r>
              <a:rPr lang="en-GB" dirty="0" err="1"/>
              <a:t>SepH</a:t>
            </a:r>
            <a:r>
              <a:rPr lang="en-GB" dirty="0"/>
              <a:t> 3.5</a:t>
            </a: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4D4CB4E4-04F1-4189-A3FC-422E3031AD09}"/>
              </a:ext>
            </a:extLst>
          </p:cNvPr>
          <p:cNvCxnSpPr/>
          <p:nvPr/>
        </p:nvCxnSpPr>
        <p:spPr>
          <a:xfrm>
            <a:off x="8160156" y="1185898"/>
            <a:ext cx="218541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3C2CE6CD-85D7-4801-BAA3-ABD875CF0B1F}"/>
              </a:ext>
            </a:extLst>
          </p:cNvPr>
          <p:cNvCxnSpPr>
            <a:cxnSpLocks/>
          </p:cNvCxnSpPr>
          <p:nvPr/>
        </p:nvCxnSpPr>
        <p:spPr>
          <a:xfrm>
            <a:off x="8229727" y="1548610"/>
            <a:ext cx="106735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338899DE-BFDB-4C2F-AC90-2B79E2BC4C04}"/>
              </a:ext>
            </a:extLst>
          </p:cNvPr>
          <p:cNvCxnSpPr>
            <a:cxnSpLocks/>
          </p:cNvCxnSpPr>
          <p:nvPr/>
        </p:nvCxnSpPr>
        <p:spPr>
          <a:xfrm>
            <a:off x="9453346" y="1551779"/>
            <a:ext cx="106735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8DB6302B-3745-4727-BB25-DFBC8BBE05A8}"/>
              </a:ext>
            </a:extLst>
          </p:cNvPr>
          <p:cNvSpPr txBox="1"/>
          <p:nvPr/>
        </p:nvSpPr>
        <p:spPr>
          <a:xfrm>
            <a:off x="8371555" y="1212544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- GTP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21C0FF2-0537-44BC-8A9F-93B394F98993}"/>
              </a:ext>
            </a:extLst>
          </p:cNvPr>
          <p:cNvSpPr txBox="1"/>
          <p:nvPr/>
        </p:nvSpPr>
        <p:spPr>
          <a:xfrm>
            <a:off x="9604547" y="1190853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+ GTP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F1D9BEA-DAC9-4062-80E4-5592C04C03D9}"/>
              </a:ext>
            </a:extLst>
          </p:cNvPr>
          <p:cNvSpPr txBox="1"/>
          <p:nvPr/>
        </p:nvSpPr>
        <p:spPr>
          <a:xfrm>
            <a:off x="5569117" y="6488668"/>
            <a:ext cx="13173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4,000 RPM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D73AFE98-42F4-4089-9E94-CAE8713E15D5}"/>
              </a:ext>
            </a:extLst>
          </p:cNvPr>
          <p:cNvSpPr/>
          <p:nvPr/>
        </p:nvSpPr>
        <p:spPr>
          <a:xfrm>
            <a:off x="2984430" y="4778444"/>
            <a:ext cx="69442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5.1%</a:t>
            </a:r>
            <a:r>
              <a:rPr lang="en-GB" dirty="0"/>
              <a:t> 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7DE27DB-B2DC-4B18-A8FD-CC34F3902826}"/>
              </a:ext>
            </a:extLst>
          </p:cNvPr>
          <p:cNvSpPr txBox="1"/>
          <p:nvPr/>
        </p:nvSpPr>
        <p:spPr>
          <a:xfrm>
            <a:off x="704196" y="4778444"/>
            <a:ext cx="21096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% </a:t>
            </a:r>
            <a:r>
              <a:rPr lang="en-GB" sz="1400" dirty="0" err="1"/>
              <a:t>FtsZ</a:t>
            </a:r>
            <a:r>
              <a:rPr lang="en-GB" sz="1400" dirty="0"/>
              <a:t> in pellet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852E43C-8B99-436D-991C-D0BB056D830E}"/>
              </a:ext>
            </a:extLst>
          </p:cNvPr>
          <p:cNvSpPr txBox="1"/>
          <p:nvPr/>
        </p:nvSpPr>
        <p:spPr>
          <a:xfrm>
            <a:off x="661616" y="5239198"/>
            <a:ext cx="21096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% </a:t>
            </a:r>
            <a:r>
              <a:rPr lang="en-GB" sz="1400" dirty="0" err="1"/>
              <a:t>SepH</a:t>
            </a:r>
            <a:r>
              <a:rPr lang="en-GB" sz="1400" dirty="0"/>
              <a:t> in pellet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F943579D-BCA3-491C-BCB7-D8423D8CC691}"/>
              </a:ext>
            </a:extLst>
          </p:cNvPr>
          <p:cNvSpPr/>
          <p:nvPr/>
        </p:nvSpPr>
        <p:spPr>
          <a:xfrm>
            <a:off x="4186609" y="4778444"/>
            <a:ext cx="69532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5.3%</a:t>
            </a:r>
            <a:r>
              <a:rPr lang="en-GB" dirty="0"/>
              <a:t> </a:t>
            </a:r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C810FB3E-BC0A-41E1-B304-7543FF4E1AE7}"/>
              </a:ext>
            </a:extLst>
          </p:cNvPr>
          <p:cNvSpPr/>
          <p:nvPr/>
        </p:nvSpPr>
        <p:spPr>
          <a:xfrm>
            <a:off x="5309521" y="4778444"/>
            <a:ext cx="69532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3.4%</a:t>
            </a:r>
            <a:r>
              <a:rPr lang="en-GB" dirty="0"/>
              <a:t> </a:t>
            </a: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D985F2DA-B1BF-4997-9B74-9ED970553175}"/>
              </a:ext>
            </a:extLst>
          </p:cNvPr>
          <p:cNvSpPr/>
          <p:nvPr/>
        </p:nvSpPr>
        <p:spPr>
          <a:xfrm>
            <a:off x="6360710" y="4747590"/>
            <a:ext cx="69532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3.1%</a:t>
            </a:r>
            <a:r>
              <a:rPr lang="en-GB" dirty="0"/>
              <a:t> </a:t>
            </a: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A1ED8A93-BC4A-4748-8646-8AA231CB6B71}"/>
              </a:ext>
            </a:extLst>
          </p:cNvPr>
          <p:cNvSpPr/>
          <p:nvPr/>
        </p:nvSpPr>
        <p:spPr>
          <a:xfrm>
            <a:off x="5334000" y="5146744"/>
            <a:ext cx="69532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8.8%</a:t>
            </a:r>
            <a:r>
              <a:rPr lang="en-GB" dirty="0"/>
              <a:t> </a:t>
            </a:r>
          </a:p>
        </p:txBody>
      </p:sp>
      <p:sp>
        <p:nvSpPr>
          <p:cNvPr id="43" name="Rectangle 42">
            <a:extLst>
              <a:ext uri="{FF2B5EF4-FFF2-40B4-BE49-F238E27FC236}">
                <a16:creationId xmlns:a16="http://schemas.microsoft.com/office/drawing/2014/main" id="{7C351030-D369-490F-A670-F8CA3D81E143}"/>
              </a:ext>
            </a:extLst>
          </p:cNvPr>
          <p:cNvSpPr/>
          <p:nvPr/>
        </p:nvSpPr>
        <p:spPr>
          <a:xfrm>
            <a:off x="6301972" y="5146744"/>
            <a:ext cx="81280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10.4%</a:t>
            </a:r>
            <a:r>
              <a:rPr lang="en-GB" dirty="0"/>
              <a:t> </a:t>
            </a:r>
          </a:p>
        </p:txBody>
      </p:sp>
      <p:sp>
        <p:nvSpPr>
          <p:cNvPr id="44" name="Rectangle 43">
            <a:extLst>
              <a:ext uri="{FF2B5EF4-FFF2-40B4-BE49-F238E27FC236}">
                <a16:creationId xmlns:a16="http://schemas.microsoft.com/office/drawing/2014/main" id="{636ABD46-9D66-4E87-86AA-6238F364CDE8}"/>
              </a:ext>
            </a:extLst>
          </p:cNvPr>
          <p:cNvSpPr/>
          <p:nvPr/>
        </p:nvSpPr>
        <p:spPr>
          <a:xfrm>
            <a:off x="3239979" y="5135736"/>
            <a:ext cx="2551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-</a:t>
            </a:r>
            <a:endParaRPr lang="en-GB" dirty="0"/>
          </a:p>
        </p:txBody>
      </p:sp>
      <p:sp>
        <p:nvSpPr>
          <p:cNvPr id="45" name="Rectangle 44">
            <a:extLst>
              <a:ext uri="{FF2B5EF4-FFF2-40B4-BE49-F238E27FC236}">
                <a16:creationId xmlns:a16="http://schemas.microsoft.com/office/drawing/2014/main" id="{4E099C91-11C4-4FC7-B5EF-9C71B2E5F239}"/>
              </a:ext>
            </a:extLst>
          </p:cNvPr>
          <p:cNvSpPr/>
          <p:nvPr/>
        </p:nvSpPr>
        <p:spPr>
          <a:xfrm>
            <a:off x="4392079" y="5144379"/>
            <a:ext cx="2551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-</a:t>
            </a:r>
            <a:endParaRPr lang="en-GB" dirty="0"/>
          </a:p>
        </p:txBody>
      </p:sp>
      <p:sp>
        <p:nvSpPr>
          <p:cNvPr id="46" name="Rectangle 45">
            <a:extLst>
              <a:ext uri="{FF2B5EF4-FFF2-40B4-BE49-F238E27FC236}">
                <a16:creationId xmlns:a16="http://schemas.microsoft.com/office/drawing/2014/main" id="{4BC14171-F2B8-4172-B2BE-F2B1CDD36DE7}"/>
              </a:ext>
            </a:extLst>
          </p:cNvPr>
          <p:cNvSpPr/>
          <p:nvPr/>
        </p:nvSpPr>
        <p:spPr>
          <a:xfrm>
            <a:off x="8601755" y="4778444"/>
            <a:ext cx="69532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>
                <a:solidFill>
                  <a:srgbClr val="000000"/>
                </a:solidFill>
                <a:latin typeface="Calibri" panose="020F0502020204030204" pitchFamily="34" charset="0"/>
              </a:rPr>
              <a:t>6.6%</a:t>
            </a:r>
            <a:r>
              <a:rPr lang="en-GB"/>
              <a:t> </a:t>
            </a:r>
            <a:endParaRPr lang="en-GB" dirty="0"/>
          </a:p>
        </p:txBody>
      </p:sp>
      <p:sp>
        <p:nvSpPr>
          <p:cNvPr id="47" name="Rectangle 46">
            <a:extLst>
              <a:ext uri="{FF2B5EF4-FFF2-40B4-BE49-F238E27FC236}">
                <a16:creationId xmlns:a16="http://schemas.microsoft.com/office/drawing/2014/main" id="{006E74B5-2E78-4574-B453-D2A18FEA754C}"/>
              </a:ext>
            </a:extLst>
          </p:cNvPr>
          <p:cNvSpPr/>
          <p:nvPr/>
        </p:nvSpPr>
        <p:spPr>
          <a:xfrm>
            <a:off x="9987022" y="4778444"/>
            <a:ext cx="69532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4.2%</a:t>
            </a:r>
            <a:r>
              <a:rPr lang="en-GB" dirty="0"/>
              <a:t> </a:t>
            </a:r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C2F76772-85DA-4B53-ADBD-E1379C9D7059}"/>
              </a:ext>
            </a:extLst>
          </p:cNvPr>
          <p:cNvSpPr/>
          <p:nvPr/>
        </p:nvSpPr>
        <p:spPr>
          <a:xfrm>
            <a:off x="8601755" y="5145411"/>
            <a:ext cx="69532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7.7%</a:t>
            </a:r>
            <a:r>
              <a:rPr lang="en-GB" dirty="0"/>
              <a:t> </a:t>
            </a: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CFC420E2-38CE-4A85-A5A8-2DC1071A707A}"/>
              </a:ext>
            </a:extLst>
          </p:cNvPr>
          <p:cNvSpPr/>
          <p:nvPr/>
        </p:nvSpPr>
        <p:spPr>
          <a:xfrm>
            <a:off x="9997909" y="5152699"/>
            <a:ext cx="69532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7.3%</a:t>
            </a:r>
            <a:r>
              <a:rPr lang="en-GB" dirty="0"/>
              <a:t> 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A8C0F743-ECA6-4565-A6AB-9E96009CA388}"/>
              </a:ext>
            </a:extLst>
          </p:cNvPr>
          <p:cNvSpPr txBox="1"/>
          <p:nvPr/>
        </p:nvSpPr>
        <p:spPr>
          <a:xfrm>
            <a:off x="-71253" y="-57592"/>
            <a:ext cx="14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Experiment 1</a:t>
            </a:r>
          </a:p>
        </p:txBody>
      </p:sp>
    </p:spTree>
    <p:extLst>
      <p:ext uri="{BB962C8B-B14F-4D97-AF65-F5344CB8AC3E}">
        <p14:creationId xmlns:p14="http://schemas.microsoft.com/office/powerpoint/2010/main" val="7970640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A picture containing flying, plane, airplane, water&#10;&#10;Description automatically generated">
            <a:extLst>
              <a:ext uri="{FF2B5EF4-FFF2-40B4-BE49-F238E27FC236}">
                <a16:creationId xmlns:a16="http://schemas.microsoft.com/office/drawing/2014/main" id="{D35F45A9-B9A5-4DFC-B0C3-906EFE56370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629" t="26905" r="20087" b="26398"/>
          <a:stretch/>
        </p:blipFill>
        <p:spPr>
          <a:xfrm>
            <a:off x="1855151" y="1677629"/>
            <a:ext cx="5786760" cy="3103916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98A9C022-3C1D-4FD4-B964-6C35E4A84D66}"/>
              </a:ext>
            </a:extLst>
          </p:cNvPr>
          <p:cNvSpPr txBox="1"/>
          <p:nvPr/>
        </p:nvSpPr>
        <p:spPr>
          <a:xfrm>
            <a:off x="3076941" y="608073"/>
            <a:ext cx="13990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FtsZ</a:t>
            </a:r>
            <a:r>
              <a:rPr lang="en-GB" dirty="0"/>
              <a:t> 3.5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04D23C2-00E3-48CE-8606-0CA38A990811}"/>
              </a:ext>
            </a:extLst>
          </p:cNvPr>
          <p:cNvSpPr txBox="1"/>
          <p:nvPr/>
        </p:nvSpPr>
        <p:spPr>
          <a:xfrm>
            <a:off x="4828017" y="608073"/>
            <a:ext cx="1987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FtsZ</a:t>
            </a:r>
            <a:r>
              <a:rPr lang="en-GB" dirty="0"/>
              <a:t> 3.5 : </a:t>
            </a:r>
            <a:r>
              <a:rPr lang="en-GB" dirty="0" err="1"/>
              <a:t>SepH</a:t>
            </a:r>
            <a:r>
              <a:rPr lang="en-GB" dirty="0"/>
              <a:t> 0.6</a:t>
            </a: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17D1A775-D672-4832-81B4-50E67A9CDDAA}"/>
              </a:ext>
            </a:extLst>
          </p:cNvPr>
          <p:cNvCxnSpPr/>
          <p:nvPr/>
        </p:nvCxnSpPr>
        <p:spPr>
          <a:xfrm>
            <a:off x="2473437" y="977405"/>
            <a:ext cx="218541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028AB4D7-8E5F-410C-AB3C-3F7085B56286}"/>
              </a:ext>
            </a:extLst>
          </p:cNvPr>
          <p:cNvCxnSpPr/>
          <p:nvPr/>
        </p:nvCxnSpPr>
        <p:spPr>
          <a:xfrm>
            <a:off x="4728957" y="977405"/>
            <a:ext cx="218541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B1E08B30-51CC-452C-9DC8-F4CD0E73DCFF}"/>
              </a:ext>
            </a:extLst>
          </p:cNvPr>
          <p:cNvCxnSpPr>
            <a:cxnSpLocks/>
          </p:cNvCxnSpPr>
          <p:nvPr/>
        </p:nvCxnSpPr>
        <p:spPr>
          <a:xfrm>
            <a:off x="2473437" y="1340117"/>
            <a:ext cx="106735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3FDEADFD-C70B-4EB1-843F-0E32D9C99AB2}"/>
              </a:ext>
            </a:extLst>
          </p:cNvPr>
          <p:cNvCxnSpPr>
            <a:cxnSpLocks/>
          </p:cNvCxnSpPr>
          <p:nvPr/>
        </p:nvCxnSpPr>
        <p:spPr>
          <a:xfrm>
            <a:off x="3639094" y="1340117"/>
            <a:ext cx="106735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C4618496-E256-44DB-B1A8-6F3C8DC5CA08}"/>
              </a:ext>
            </a:extLst>
          </p:cNvPr>
          <p:cNvCxnSpPr>
            <a:cxnSpLocks/>
          </p:cNvCxnSpPr>
          <p:nvPr/>
        </p:nvCxnSpPr>
        <p:spPr>
          <a:xfrm>
            <a:off x="4798528" y="1340117"/>
            <a:ext cx="106735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C86262B4-8D21-4A1F-8C7A-A21F8B1E0479}"/>
              </a:ext>
            </a:extLst>
          </p:cNvPr>
          <p:cNvCxnSpPr>
            <a:cxnSpLocks/>
          </p:cNvCxnSpPr>
          <p:nvPr/>
        </p:nvCxnSpPr>
        <p:spPr>
          <a:xfrm>
            <a:off x="5926821" y="1340117"/>
            <a:ext cx="106735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B2D190DB-3D4F-4A9A-82E1-A718139704AD}"/>
              </a:ext>
            </a:extLst>
          </p:cNvPr>
          <p:cNvSpPr txBox="1"/>
          <p:nvPr/>
        </p:nvSpPr>
        <p:spPr>
          <a:xfrm>
            <a:off x="2653269" y="995693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- GTP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3835975-1C9E-4E6D-B7CD-BF060DE3BF3D}"/>
              </a:ext>
            </a:extLst>
          </p:cNvPr>
          <p:cNvSpPr txBox="1"/>
          <p:nvPr/>
        </p:nvSpPr>
        <p:spPr>
          <a:xfrm>
            <a:off x="4940356" y="1004051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- GTP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74A18F6-A7B4-4622-9A89-46E06A1AC8B3}"/>
              </a:ext>
            </a:extLst>
          </p:cNvPr>
          <p:cNvSpPr txBox="1"/>
          <p:nvPr/>
        </p:nvSpPr>
        <p:spPr>
          <a:xfrm>
            <a:off x="3803889" y="983240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+ GTP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8BAF7F3-12AC-403D-8C41-B4AF04F1C066}"/>
              </a:ext>
            </a:extLst>
          </p:cNvPr>
          <p:cNvSpPr txBox="1"/>
          <p:nvPr/>
        </p:nvSpPr>
        <p:spPr>
          <a:xfrm>
            <a:off x="6078022" y="979191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+ GTP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1AFC213-A443-4CDC-B768-A617E7CFAC5F}"/>
              </a:ext>
            </a:extLst>
          </p:cNvPr>
          <p:cNvSpPr txBox="1"/>
          <p:nvPr/>
        </p:nvSpPr>
        <p:spPr>
          <a:xfrm>
            <a:off x="5572158" y="6467375"/>
            <a:ext cx="13173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24,000 RPM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D8CFC4AA-F620-403F-A655-75671CF73863}"/>
              </a:ext>
            </a:extLst>
          </p:cNvPr>
          <p:cNvSpPr txBox="1"/>
          <p:nvPr/>
        </p:nvSpPr>
        <p:spPr>
          <a:xfrm>
            <a:off x="1011249" y="4782491"/>
            <a:ext cx="21096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% </a:t>
            </a:r>
            <a:r>
              <a:rPr lang="en-GB" sz="1400" dirty="0" err="1"/>
              <a:t>FtsZ</a:t>
            </a:r>
            <a:r>
              <a:rPr lang="en-GB" sz="1400" dirty="0"/>
              <a:t> in pellet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44E52D1-3963-4A84-8078-189DB64C3E9C}"/>
              </a:ext>
            </a:extLst>
          </p:cNvPr>
          <p:cNvSpPr txBox="1"/>
          <p:nvPr/>
        </p:nvSpPr>
        <p:spPr>
          <a:xfrm>
            <a:off x="968669" y="5243245"/>
            <a:ext cx="21096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/>
              <a:t>% </a:t>
            </a:r>
            <a:r>
              <a:rPr lang="en-GB" sz="1400" dirty="0" err="1"/>
              <a:t>SepH</a:t>
            </a:r>
            <a:r>
              <a:rPr lang="en-GB" sz="1400" dirty="0"/>
              <a:t> in pellet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9F45487F-598C-40F1-B6B6-5D8B4E9EBD8B}"/>
              </a:ext>
            </a:extLst>
          </p:cNvPr>
          <p:cNvSpPr/>
          <p:nvPr/>
        </p:nvSpPr>
        <p:spPr>
          <a:xfrm>
            <a:off x="2893373" y="4750372"/>
            <a:ext cx="69532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2.4%</a:t>
            </a:r>
            <a:r>
              <a:rPr lang="en-GB" dirty="0"/>
              <a:t> 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CECFC8F8-1A14-4E16-81A4-ECEFD57F4F32}"/>
              </a:ext>
            </a:extLst>
          </p:cNvPr>
          <p:cNvSpPr/>
          <p:nvPr/>
        </p:nvSpPr>
        <p:spPr>
          <a:xfrm>
            <a:off x="4199650" y="4750372"/>
            <a:ext cx="69532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4.3%</a:t>
            </a:r>
            <a:r>
              <a:rPr lang="en-GB" dirty="0"/>
              <a:t> </a:t>
            </a: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01F23DAD-3332-4C6C-BC42-C4F6964D1FBC}"/>
              </a:ext>
            </a:extLst>
          </p:cNvPr>
          <p:cNvSpPr/>
          <p:nvPr/>
        </p:nvSpPr>
        <p:spPr>
          <a:xfrm>
            <a:off x="5289719" y="4781545"/>
            <a:ext cx="69532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1.5%</a:t>
            </a:r>
            <a:r>
              <a:rPr lang="en-GB" dirty="0"/>
              <a:t> 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57A998CB-B1CB-45BB-A85B-B763F89A716E}"/>
              </a:ext>
            </a:extLst>
          </p:cNvPr>
          <p:cNvSpPr/>
          <p:nvPr/>
        </p:nvSpPr>
        <p:spPr>
          <a:xfrm>
            <a:off x="6556030" y="4781545"/>
            <a:ext cx="69532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2.5%</a:t>
            </a:r>
            <a:r>
              <a:rPr lang="en-GB" dirty="0"/>
              <a:t> </a:t>
            </a: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9021DF39-C372-4086-8C7C-F92721BC0541}"/>
              </a:ext>
            </a:extLst>
          </p:cNvPr>
          <p:cNvSpPr/>
          <p:nvPr/>
        </p:nvSpPr>
        <p:spPr>
          <a:xfrm>
            <a:off x="5275488" y="5220162"/>
            <a:ext cx="69442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/>
              <a:t>9.4% </a:t>
            </a:r>
            <a:endParaRPr lang="en-GB" dirty="0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AD5F8F55-4F4C-4176-AF8F-77D3C4A2CAB3}"/>
              </a:ext>
            </a:extLst>
          </p:cNvPr>
          <p:cNvSpPr/>
          <p:nvPr/>
        </p:nvSpPr>
        <p:spPr>
          <a:xfrm>
            <a:off x="6551965" y="5182722"/>
            <a:ext cx="81144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/>
              <a:t>11.7% </a:t>
            </a:r>
            <a:endParaRPr lang="en-GB" dirty="0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DB0F5AAE-DE49-4BE2-9590-1292F10525A5}"/>
              </a:ext>
            </a:extLst>
          </p:cNvPr>
          <p:cNvSpPr/>
          <p:nvPr/>
        </p:nvSpPr>
        <p:spPr>
          <a:xfrm>
            <a:off x="3051105" y="5182722"/>
            <a:ext cx="2551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-</a:t>
            </a:r>
            <a:endParaRPr lang="en-GB" dirty="0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D9A89292-37B6-4AB8-9D75-8C2B5D2840CC}"/>
              </a:ext>
            </a:extLst>
          </p:cNvPr>
          <p:cNvSpPr/>
          <p:nvPr/>
        </p:nvSpPr>
        <p:spPr>
          <a:xfrm>
            <a:off x="4392366" y="5118672"/>
            <a:ext cx="25519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-</a:t>
            </a:r>
            <a:endParaRPr lang="en-GB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CC718E2-245D-4728-B0EC-F12363743B71}"/>
              </a:ext>
            </a:extLst>
          </p:cNvPr>
          <p:cNvSpPr txBox="1"/>
          <p:nvPr/>
        </p:nvSpPr>
        <p:spPr>
          <a:xfrm>
            <a:off x="2623963" y="1335062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7B272E90-D179-419F-8409-68BB19AECAF7}"/>
              </a:ext>
            </a:extLst>
          </p:cNvPr>
          <p:cNvSpPr txBox="1"/>
          <p:nvPr/>
        </p:nvSpPr>
        <p:spPr>
          <a:xfrm>
            <a:off x="3817255" y="1335062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D9572B39-6366-4BD4-A7EE-AA15085117D9}"/>
              </a:ext>
            </a:extLst>
          </p:cNvPr>
          <p:cNvSpPr txBox="1"/>
          <p:nvPr/>
        </p:nvSpPr>
        <p:spPr>
          <a:xfrm>
            <a:off x="4855099" y="1335062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3170412-53B2-48C2-A933-386989E05281}"/>
              </a:ext>
            </a:extLst>
          </p:cNvPr>
          <p:cNvSpPr txBox="1"/>
          <p:nvPr/>
        </p:nvSpPr>
        <p:spPr>
          <a:xfrm>
            <a:off x="6075406" y="1335062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C860A43-0DF1-408A-8D6F-2DFE87DF488A}"/>
              </a:ext>
            </a:extLst>
          </p:cNvPr>
          <p:cNvSpPr txBox="1"/>
          <p:nvPr/>
        </p:nvSpPr>
        <p:spPr>
          <a:xfrm>
            <a:off x="3243260" y="1335062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8B7B17A-95F7-479F-8D1E-33E2706D28C5}"/>
              </a:ext>
            </a:extLst>
          </p:cNvPr>
          <p:cNvSpPr txBox="1"/>
          <p:nvPr/>
        </p:nvSpPr>
        <p:spPr>
          <a:xfrm>
            <a:off x="4347957" y="1335062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46381344-5D25-4ACA-8ABC-C160AEA04891}"/>
              </a:ext>
            </a:extLst>
          </p:cNvPr>
          <p:cNvSpPr txBox="1"/>
          <p:nvPr/>
        </p:nvSpPr>
        <p:spPr>
          <a:xfrm>
            <a:off x="5440065" y="1335062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DED1FBB9-6371-4CD4-9B71-44BE798A46D3}"/>
              </a:ext>
            </a:extLst>
          </p:cNvPr>
          <p:cNvSpPr txBox="1"/>
          <p:nvPr/>
        </p:nvSpPr>
        <p:spPr>
          <a:xfrm>
            <a:off x="6602827" y="1335062"/>
            <a:ext cx="3108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P</a:t>
            </a:r>
          </a:p>
        </p:txBody>
      </p:sp>
      <p:pic>
        <p:nvPicPr>
          <p:cNvPr id="47" name="Picture 46" descr="A picture containing water, photo, sitting, small&#10;&#10;Description automatically generated">
            <a:extLst>
              <a:ext uri="{FF2B5EF4-FFF2-40B4-BE49-F238E27FC236}">
                <a16:creationId xmlns:a16="http://schemas.microsoft.com/office/drawing/2014/main" id="{609FD5BD-E33E-4704-99DF-F09CDB99213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181" t="33560" r="54214" b="15498"/>
          <a:stretch/>
        </p:blipFill>
        <p:spPr>
          <a:xfrm>
            <a:off x="7943513" y="1704394"/>
            <a:ext cx="2577186" cy="3019425"/>
          </a:xfrm>
          <a:prstGeom prst="rect">
            <a:avLst/>
          </a:prstGeom>
        </p:spPr>
      </p:pic>
      <p:sp>
        <p:nvSpPr>
          <p:cNvPr id="48" name="TextBox 47">
            <a:extLst>
              <a:ext uri="{FF2B5EF4-FFF2-40B4-BE49-F238E27FC236}">
                <a16:creationId xmlns:a16="http://schemas.microsoft.com/office/drawing/2014/main" id="{612669E9-2386-45E0-B635-DA8E524391CB}"/>
              </a:ext>
            </a:extLst>
          </p:cNvPr>
          <p:cNvSpPr txBox="1"/>
          <p:nvPr/>
        </p:nvSpPr>
        <p:spPr>
          <a:xfrm>
            <a:off x="8358276" y="795492"/>
            <a:ext cx="198729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FtsZ</a:t>
            </a:r>
            <a:r>
              <a:rPr lang="en-GB" dirty="0"/>
              <a:t> 3.5 : </a:t>
            </a:r>
            <a:r>
              <a:rPr lang="en-GB" dirty="0" err="1"/>
              <a:t>SepH</a:t>
            </a:r>
            <a:r>
              <a:rPr lang="en-GB" dirty="0"/>
              <a:t> 3.5</a:t>
            </a: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4EC3BFB0-DB46-49C0-A490-72C6FD492E42}"/>
              </a:ext>
            </a:extLst>
          </p:cNvPr>
          <p:cNvCxnSpPr/>
          <p:nvPr/>
        </p:nvCxnSpPr>
        <p:spPr>
          <a:xfrm>
            <a:off x="8160156" y="1185898"/>
            <a:ext cx="218541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652B1DA8-4F68-4950-92D9-0A914AB27E5A}"/>
              </a:ext>
            </a:extLst>
          </p:cNvPr>
          <p:cNvCxnSpPr>
            <a:cxnSpLocks/>
          </p:cNvCxnSpPr>
          <p:nvPr/>
        </p:nvCxnSpPr>
        <p:spPr>
          <a:xfrm>
            <a:off x="8229727" y="1548610"/>
            <a:ext cx="106735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69D41C06-C300-4F9E-AA8C-CC5FACC59BB9}"/>
              </a:ext>
            </a:extLst>
          </p:cNvPr>
          <p:cNvCxnSpPr>
            <a:cxnSpLocks/>
          </p:cNvCxnSpPr>
          <p:nvPr/>
        </p:nvCxnSpPr>
        <p:spPr>
          <a:xfrm>
            <a:off x="9453346" y="1551779"/>
            <a:ext cx="1067353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939FECB1-6AC3-445B-A36F-D01DD695A04D}"/>
              </a:ext>
            </a:extLst>
          </p:cNvPr>
          <p:cNvSpPr txBox="1"/>
          <p:nvPr/>
        </p:nvSpPr>
        <p:spPr>
          <a:xfrm>
            <a:off x="8371555" y="1212544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- GTP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04FC9BBA-4006-4873-B154-E6FAB64D5FA6}"/>
              </a:ext>
            </a:extLst>
          </p:cNvPr>
          <p:cNvSpPr txBox="1"/>
          <p:nvPr/>
        </p:nvSpPr>
        <p:spPr>
          <a:xfrm>
            <a:off x="9604547" y="1190853"/>
            <a:ext cx="1306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+ GTP</a:t>
            </a: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C2F8615F-D3D7-4B9C-9D1A-A244AAD43D3F}"/>
              </a:ext>
            </a:extLst>
          </p:cNvPr>
          <p:cNvSpPr/>
          <p:nvPr/>
        </p:nvSpPr>
        <p:spPr>
          <a:xfrm>
            <a:off x="8830214" y="4750372"/>
            <a:ext cx="69532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7.1%</a:t>
            </a:r>
            <a:r>
              <a:rPr lang="en-GB" dirty="0"/>
              <a:t> </a:t>
            </a: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D0EAB3BA-9407-4CCB-BE22-CEF6499BD561}"/>
              </a:ext>
            </a:extLst>
          </p:cNvPr>
          <p:cNvSpPr/>
          <p:nvPr/>
        </p:nvSpPr>
        <p:spPr>
          <a:xfrm>
            <a:off x="9987022" y="4781545"/>
            <a:ext cx="69532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3.9%</a:t>
            </a:r>
            <a:r>
              <a:rPr lang="en-GB" dirty="0"/>
              <a:t> </a:t>
            </a: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A9E4E896-A3E2-4CEE-BA29-3072785864B7}"/>
              </a:ext>
            </a:extLst>
          </p:cNvPr>
          <p:cNvSpPr/>
          <p:nvPr/>
        </p:nvSpPr>
        <p:spPr>
          <a:xfrm>
            <a:off x="8791747" y="5118672"/>
            <a:ext cx="812800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11.1%</a:t>
            </a:r>
            <a:r>
              <a:rPr lang="en-GB" dirty="0"/>
              <a:t> </a:t>
            </a: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2473ADE5-5D95-4721-8687-66C2FC12E0DE}"/>
              </a:ext>
            </a:extLst>
          </p:cNvPr>
          <p:cNvSpPr/>
          <p:nvPr/>
        </p:nvSpPr>
        <p:spPr>
          <a:xfrm>
            <a:off x="10058058" y="5118672"/>
            <a:ext cx="69532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>
                <a:solidFill>
                  <a:srgbClr val="000000"/>
                </a:solidFill>
                <a:latin typeface="Calibri" panose="020F0502020204030204" pitchFamily="34" charset="0"/>
              </a:rPr>
              <a:t>6.1%</a:t>
            </a:r>
            <a:r>
              <a:rPr lang="en-GB" dirty="0"/>
              <a:t>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AFF7B9A-9935-4385-A459-C70C67B14402}"/>
              </a:ext>
            </a:extLst>
          </p:cNvPr>
          <p:cNvSpPr txBox="1"/>
          <p:nvPr/>
        </p:nvSpPr>
        <p:spPr>
          <a:xfrm>
            <a:off x="-71253" y="-57592"/>
            <a:ext cx="14328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Experiment 2</a:t>
            </a:r>
          </a:p>
        </p:txBody>
      </p:sp>
    </p:spTree>
    <p:extLst>
      <p:ext uri="{BB962C8B-B14F-4D97-AF65-F5344CB8AC3E}">
        <p14:creationId xmlns:p14="http://schemas.microsoft.com/office/powerpoint/2010/main" val="29689410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4</Words>
  <Application>Microsoft Office PowerPoint</Application>
  <PresentationFormat>Widescreen</PresentationFormat>
  <Paragraphs>5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san Schlimpert (JIC)</dc:creator>
  <cp:lastModifiedBy>Susan Schlimpert (JIC)</cp:lastModifiedBy>
  <cp:revision>1</cp:revision>
  <dcterms:created xsi:type="dcterms:W3CDTF">2021-01-12T19:41:22Z</dcterms:created>
  <dcterms:modified xsi:type="dcterms:W3CDTF">2021-01-12T19:41:40Z</dcterms:modified>
</cp:coreProperties>
</file>